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-672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CIMI\Users\cest_moi_cimi\Documents\Documents\Manuscripts\Submitted%20manuscript\grafik%20batang%20Berat%20Badan%20Gabunga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9.0238407699037598E-2"/>
          <c:y val="7.45487022455526E-2"/>
          <c:w val="0.87087270341207412"/>
          <c:h val="0.79822506561679807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Sheet1!$A$2:$A$6</c:f>
              <c:strCache>
                <c:ptCount val="5"/>
                <c:pt idx="0">
                  <c:v>Control (-)</c:v>
                </c:pt>
                <c:pt idx="1">
                  <c:v>Control (+)</c:v>
                </c:pt>
                <c:pt idx="2">
                  <c:v>GCE 10 mg/kg BW/d</c:v>
                </c:pt>
                <c:pt idx="3">
                  <c:v>GCE 20 mg/kgBW/d</c:v>
                </c:pt>
                <c:pt idx="4">
                  <c:v>GCE 40 mg/kgBW/d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210.2</c:v>
                </c:pt>
                <c:pt idx="1">
                  <c:v>211.4</c:v>
                </c:pt>
                <c:pt idx="2">
                  <c:v>212.8</c:v>
                </c:pt>
                <c:pt idx="3">
                  <c:v>215.2</c:v>
                </c:pt>
                <c:pt idx="4">
                  <c:v>213.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40C-5B49-96CC-821694FDB690}"/>
            </c:ext>
          </c:extLst>
        </c:ser>
        <c:ser>
          <c:idx val="1"/>
          <c:order val="1"/>
          <c:spPr>
            <a:solidFill>
              <a:schemeClr val="tx1">
                <a:lumMod val="50000"/>
                <a:lumOff val="50000"/>
              </a:schemeClr>
            </a:solidFill>
          </c:spPr>
          <c:errBars>
            <c:errBarType val="both"/>
            <c:errValType val="cust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2:$A$6</c:f>
              <c:strCache>
                <c:ptCount val="5"/>
                <c:pt idx="0">
                  <c:v>Control (-)</c:v>
                </c:pt>
                <c:pt idx="1">
                  <c:v>Control (+)</c:v>
                </c:pt>
                <c:pt idx="2">
                  <c:v>GCE 10 mg/kg BW/d</c:v>
                </c:pt>
                <c:pt idx="3">
                  <c:v>GCE 20 mg/kgBW/d</c:v>
                </c:pt>
                <c:pt idx="4">
                  <c:v>GCE 40 mg/kgBW/d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234.8</c:v>
                </c:pt>
                <c:pt idx="1">
                  <c:v>392.8</c:v>
                </c:pt>
                <c:pt idx="2">
                  <c:v>391.4</c:v>
                </c:pt>
                <c:pt idx="3">
                  <c:v>392.6</c:v>
                </c:pt>
                <c:pt idx="4">
                  <c:v>391.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40C-5B49-96CC-821694FDB690}"/>
            </c:ext>
          </c:extLst>
        </c:ser>
        <c:ser>
          <c:idx val="2"/>
          <c:order val="2"/>
          <c:spPr>
            <a:solidFill>
              <a:schemeClr val="tx1"/>
            </a:solidFill>
            <a:ln>
              <a:noFill/>
            </a:ln>
          </c:spPr>
          <c:errBars>
            <c:errBarType val="both"/>
            <c:errValType val="cust"/>
            <c:plus>
              <c:numLit>
                <c:formatCode>General</c:formatCode>
                <c:ptCount val="15"/>
                <c:pt idx="0">
                  <c:v>3.56</c:v>
                </c:pt>
                <c:pt idx="1">
                  <c:v>3.84</c:v>
                </c:pt>
                <c:pt idx="2">
                  <c:v>6.09</c:v>
                </c:pt>
                <c:pt idx="3">
                  <c:v>3.56</c:v>
                </c:pt>
                <c:pt idx="4">
                  <c:v>6.6499999999999986</c:v>
                </c:pt>
                <c:pt idx="5">
                  <c:v>5.89</c:v>
                </c:pt>
                <c:pt idx="6">
                  <c:v>5.71</c:v>
                </c:pt>
                <c:pt idx="7">
                  <c:v>4.8199999999999976</c:v>
                </c:pt>
                <c:pt idx="8">
                  <c:v>5.81</c:v>
                </c:pt>
                <c:pt idx="9">
                  <c:v>4.03</c:v>
                </c:pt>
                <c:pt idx="10">
                  <c:v>6.2</c:v>
                </c:pt>
                <c:pt idx="11">
                  <c:v>8.3000000000000007</c:v>
                </c:pt>
                <c:pt idx="12">
                  <c:v>4.8</c:v>
                </c:pt>
                <c:pt idx="13">
                  <c:v>4.2</c:v>
                </c:pt>
                <c:pt idx="14">
                  <c:v>37.65</c:v>
                </c:pt>
              </c:numLit>
            </c:plus>
            <c:minus>
              <c:numLit>
                <c:formatCode>General</c:formatCode>
                <c:ptCount val="15"/>
                <c:pt idx="0">
                  <c:v>3.56</c:v>
                </c:pt>
                <c:pt idx="1">
                  <c:v>3.84</c:v>
                </c:pt>
                <c:pt idx="2">
                  <c:v>6.09</c:v>
                </c:pt>
                <c:pt idx="3">
                  <c:v>3.56</c:v>
                </c:pt>
                <c:pt idx="4">
                  <c:v>4.6499999999999986</c:v>
                </c:pt>
                <c:pt idx="5">
                  <c:v>5.89</c:v>
                </c:pt>
                <c:pt idx="6">
                  <c:v>5.71</c:v>
                </c:pt>
                <c:pt idx="7">
                  <c:v>4.8199999999999976</c:v>
                </c:pt>
                <c:pt idx="8">
                  <c:v>5.81</c:v>
                </c:pt>
                <c:pt idx="9">
                  <c:v>4.03</c:v>
                </c:pt>
                <c:pt idx="10">
                  <c:v>6.2</c:v>
                </c:pt>
                <c:pt idx="11">
                  <c:v>8.3000000000000007</c:v>
                </c:pt>
                <c:pt idx="12">
                  <c:v>4.8</c:v>
                </c:pt>
                <c:pt idx="13">
                  <c:v>4.2</c:v>
                </c:pt>
                <c:pt idx="14">
                  <c:v>37.65</c:v>
                </c:pt>
              </c:numLit>
            </c:minus>
          </c:errBars>
          <c:cat>
            <c:strRef>
              <c:f>Sheet1!$A$2:$A$6</c:f>
              <c:strCache>
                <c:ptCount val="5"/>
                <c:pt idx="0">
                  <c:v>Control (-)</c:v>
                </c:pt>
                <c:pt idx="1">
                  <c:v>Control (+)</c:v>
                </c:pt>
                <c:pt idx="2">
                  <c:v>GCE 10 mg/kg BW/d</c:v>
                </c:pt>
                <c:pt idx="3">
                  <c:v>GCE 20 mg/kgBW/d</c:v>
                </c:pt>
                <c:pt idx="4">
                  <c:v>GCE 40 mg/kgBW/d</c:v>
                </c:pt>
              </c:strCache>
            </c:strRef>
          </c:cat>
          <c:val>
            <c:numRef>
              <c:f>Sheet1!$D$2:$D$6</c:f>
              <c:numCache>
                <c:formatCode>General</c:formatCode>
                <c:ptCount val="5"/>
                <c:pt idx="0">
                  <c:v>255.6</c:v>
                </c:pt>
                <c:pt idx="1">
                  <c:v>431.2</c:v>
                </c:pt>
                <c:pt idx="2">
                  <c:v>355</c:v>
                </c:pt>
                <c:pt idx="3">
                  <c:v>329.4</c:v>
                </c:pt>
                <c:pt idx="4">
                  <c:v>275.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40C-5B49-96CC-821694FDB690}"/>
            </c:ext>
          </c:extLst>
        </c:ser>
        <c:dLbls/>
        <c:axId val="151528192"/>
        <c:axId val="151529728"/>
      </c:barChart>
      <c:catAx>
        <c:axId val="151528192"/>
        <c:scaling>
          <c:orientation val="minMax"/>
        </c:scaling>
        <c:axPos val="b"/>
        <c:numFmt formatCode="General" sourceLinked="0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51529728"/>
        <c:crossesAt val="200"/>
        <c:auto val="1"/>
        <c:lblAlgn val="ctr"/>
        <c:lblOffset val="100"/>
      </c:catAx>
      <c:valAx>
        <c:axId val="151529728"/>
        <c:scaling>
          <c:orientation val="minMax"/>
          <c:max val="500"/>
          <c:min val="200"/>
        </c:scaling>
        <c:axPos val="l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51528192"/>
        <c:crosses val="autoZero"/>
        <c:crossBetween val="between"/>
        <c:majorUnit val="100"/>
        <c:minorUnit val="50"/>
      </c:valAx>
    </c:plotArea>
    <c:plotVisOnly val="1"/>
    <c:dispBlanksAs val="gap"/>
  </c:chart>
  <c:spPr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B821F-BBEE-294D-9426-C3A43D25EB48}" type="datetimeFigureOut">
              <a:rPr lang="en-US" smtClean="0"/>
              <a:pPr/>
              <a:t>4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6B918-CC20-D844-9225-ACE8A157CC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1900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B821F-BBEE-294D-9426-C3A43D25EB48}" type="datetimeFigureOut">
              <a:rPr lang="en-US" smtClean="0"/>
              <a:pPr/>
              <a:t>4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6B918-CC20-D844-9225-ACE8A157CC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884101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B821F-BBEE-294D-9426-C3A43D25EB48}" type="datetimeFigureOut">
              <a:rPr lang="en-US" smtClean="0"/>
              <a:pPr/>
              <a:t>4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6B918-CC20-D844-9225-ACE8A157CC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28148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B821F-BBEE-294D-9426-C3A43D25EB48}" type="datetimeFigureOut">
              <a:rPr lang="en-US" smtClean="0"/>
              <a:pPr/>
              <a:t>4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6B918-CC20-D844-9225-ACE8A157CC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71169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B821F-BBEE-294D-9426-C3A43D25EB48}" type="datetimeFigureOut">
              <a:rPr lang="en-US" smtClean="0"/>
              <a:pPr/>
              <a:t>4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6B918-CC20-D844-9225-ACE8A157CC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587475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B821F-BBEE-294D-9426-C3A43D25EB48}" type="datetimeFigureOut">
              <a:rPr lang="en-US" smtClean="0"/>
              <a:pPr/>
              <a:t>4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6B918-CC20-D844-9225-ACE8A157CC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4281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B821F-BBEE-294D-9426-C3A43D25EB48}" type="datetimeFigureOut">
              <a:rPr lang="en-US" smtClean="0"/>
              <a:pPr/>
              <a:t>4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6B918-CC20-D844-9225-ACE8A157CC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88669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B821F-BBEE-294D-9426-C3A43D25EB48}" type="datetimeFigureOut">
              <a:rPr lang="en-US" smtClean="0"/>
              <a:pPr/>
              <a:t>4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6B918-CC20-D844-9225-ACE8A157CC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312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B821F-BBEE-294D-9426-C3A43D25EB48}" type="datetimeFigureOut">
              <a:rPr lang="en-US" smtClean="0"/>
              <a:pPr/>
              <a:t>4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6B918-CC20-D844-9225-ACE8A157CC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04360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B821F-BBEE-294D-9426-C3A43D25EB48}" type="datetimeFigureOut">
              <a:rPr lang="en-US" smtClean="0"/>
              <a:pPr/>
              <a:t>4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6B918-CC20-D844-9225-ACE8A157CC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3106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B821F-BBEE-294D-9426-C3A43D25EB48}" type="datetimeFigureOut">
              <a:rPr lang="en-US" smtClean="0"/>
              <a:pPr/>
              <a:t>4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6B918-CC20-D844-9225-ACE8A157CC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87562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B821F-BBEE-294D-9426-C3A43D25EB48}" type="datetimeFigureOut">
              <a:rPr lang="en-US" smtClean="0"/>
              <a:pPr/>
              <a:t>4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86B918-CC20-D844-9225-ACE8A157CC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43319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8DF24C66-1DBA-FF46-91AB-B8E7C5FB339E}"/>
              </a:ext>
            </a:extLst>
          </p:cNvPr>
          <p:cNvSpPr txBox="1"/>
          <p:nvPr/>
        </p:nvSpPr>
        <p:spPr>
          <a:xfrm>
            <a:off x="1852246" y="211015"/>
            <a:ext cx="3399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 1: Figure</a:t>
            </a:r>
            <a:endParaRPr lang="en-US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xmlns="" id="{00000000-0008-0000-0000-000006000000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995246" y="1439579"/>
          <a:ext cx="4625712" cy="27572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C298519B-3C39-1D4F-B0A9-00AA089DCA63}"/>
              </a:ext>
            </a:extLst>
          </p:cNvPr>
          <p:cNvSpPr txBox="1"/>
          <p:nvPr/>
        </p:nvSpPr>
        <p:spPr>
          <a:xfrm>
            <a:off x="3111064" y="4895203"/>
            <a:ext cx="470822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457200"/>
            <a:r>
              <a:rPr lang="en-US" sz="14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sz="14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: Figure </a:t>
            </a:r>
            <a:r>
              <a:rPr lang="en-US" sz="14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anges in rats’ body weight (g) during the high-fat diet (HFD) induction and green coffee extract (GCE) treatment. Control (-) group ate a standard diet and served as a control against which the success of HFD diet was measured. Control (+) group received HFD diet and placebo. ***p&lt;0.001 [Bonferroni test compared to Control (-)]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xmlns="" id="{3015C554-59CC-1746-A6BC-40FB8362848A}"/>
              </a:ext>
            </a:extLst>
          </p:cNvPr>
          <p:cNvGrpSpPr/>
          <p:nvPr/>
        </p:nvGrpSpPr>
        <p:grpSpPr>
          <a:xfrm>
            <a:off x="8235462" y="2275839"/>
            <a:ext cx="1922585" cy="1388232"/>
            <a:chOff x="7022123" y="1631904"/>
            <a:chExt cx="1946031" cy="1385836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xmlns="" id="{1993B263-30BD-1542-B217-2CF7321487DF}"/>
                </a:ext>
              </a:extLst>
            </p:cNvPr>
            <p:cNvSpPr/>
            <p:nvPr/>
          </p:nvSpPr>
          <p:spPr>
            <a:xfrm>
              <a:off x="7022123" y="1676400"/>
              <a:ext cx="234462" cy="2461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endParaRPr lang="en-US">
                <a:noFill/>
                <a:latin typeface="Calibri"/>
              </a:endParaRP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xmlns="" id="{E35E8A58-2E53-664C-82D6-ED8065F141D1}"/>
                </a:ext>
              </a:extLst>
            </p:cNvPr>
            <p:cNvSpPr/>
            <p:nvPr/>
          </p:nvSpPr>
          <p:spPr>
            <a:xfrm>
              <a:off x="7022123" y="2203938"/>
              <a:ext cx="234462" cy="246185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endParaRPr lang="en-US">
                <a:noFill/>
                <a:latin typeface="Calibri"/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xmlns="" id="{59EAB230-D726-BA47-993C-8535E54362AC}"/>
                </a:ext>
              </a:extLst>
            </p:cNvPr>
            <p:cNvSpPr/>
            <p:nvPr/>
          </p:nvSpPr>
          <p:spPr>
            <a:xfrm>
              <a:off x="7022123" y="2747881"/>
              <a:ext cx="234462" cy="24618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endParaRPr lang="en-US">
                <a:noFill/>
                <a:latin typeface="Calibri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FA437255-72EF-B947-B052-DB327A01CAB0}"/>
                </a:ext>
              </a:extLst>
            </p:cNvPr>
            <p:cNvSpPr txBox="1"/>
            <p:nvPr/>
          </p:nvSpPr>
          <p:spPr>
            <a:xfrm>
              <a:off x="7256585" y="1631904"/>
              <a:ext cx="17115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/>
              <a:r>
                <a:rPr lang="en-US" sz="14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re-HFD induction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D8DF043C-F7ED-6A49-92E5-00D5CEBE0F57}"/>
                </a:ext>
              </a:extLst>
            </p:cNvPr>
            <p:cNvSpPr txBox="1"/>
            <p:nvPr/>
          </p:nvSpPr>
          <p:spPr>
            <a:xfrm>
              <a:off x="7256585" y="2173141"/>
              <a:ext cx="17115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/>
              <a:r>
                <a:rPr lang="en-US" sz="14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ost-HFD induction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74FCDC98-F1A5-BD47-A254-3B07C0DC25B5}"/>
                </a:ext>
              </a:extLst>
            </p:cNvPr>
            <p:cNvSpPr txBox="1"/>
            <p:nvPr/>
          </p:nvSpPr>
          <p:spPr>
            <a:xfrm>
              <a:off x="7256585" y="2709963"/>
              <a:ext cx="15005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/>
              <a:r>
                <a:rPr lang="en-US" sz="14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CE treatment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43F56101-8BF1-4842-946C-8C17C5661873}"/>
              </a:ext>
            </a:extLst>
          </p:cNvPr>
          <p:cNvSpPr txBox="1"/>
          <p:nvPr/>
        </p:nvSpPr>
        <p:spPr>
          <a:xfrm rot="16200000">
            <a:off x="1899814" y="2515406"/>
            <a:ext cx="1840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ody weight (g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7C6EEDAD-C2B6-B047-A443-3F833E495DF1}"/>
              </a:ext>
            </a:extLst>
          </p:cNvPr>
          <p:cNvSpPr txBox="1"/>
          <p:nvPr/>
        </p:nvSpPr>
        <p:spPr>
          <a:xfrm>
            <a:off x="4185140" y="4318700"/>
            <a:ext cx="2672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eatment group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BD661BD9-AA62-4EC6-B1B6-EB03CF49B4D0}"/>
              </a:ext>
            </a:extLst>
          </p:cNvPr>
          <p:cNvSpPr txBox="1"/>
          <p:nvPr/>
        </p:nvSpPr>
        <p:spPr>
          <a:xfrm>
            <a:off x="4348480" y="2173017"/>
            <a:ext cx="518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sz="1400" b="1" dirty="0">
                <a:solidFill>
                  <a:prstClr val="black"/>
                </a:solidFill>
                <a:latin typeface="Calibri"/>
              </a:rPr>
              <a:t>***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B55F99C1-4287-4559-BEE9-3197108892E6}"/>
              </a:ext>
            </a:extLst>
          </p:cNvPr>
          <p:cNvSpPr txBox="1"/>
          <p:nvPr/>
        </p:nvSpPr>
        <p:spPr>
          <a:xfrm>
            <a:off x="5222240" y="2173017"/>
            <a:ext cx="518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sz="1400" b="1" dirty="0">
                <a:solidFill>
                  <a:prstClr val="black"/>
                </a:solidFill>
                <a:latin typeface="Calibri"/>
              </a:rPr>
              <a:t>***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D57F8E6D-6676-446E-BD6B-D885BAA91BC6}"/>
              </a:ext>
            </a:extLst>
          </p:cNvPr>
          <p:cNvSpPr txBox="1"/>
          <p:nvPr/>
        </p:nvSpPr>
        <p:spPr>
          <a:xfrm>
            <a:off x="6085840" y="2162857"/>
            <a:ext cx="518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sz="1400" b="1" dirty="0">
                <a:solidFill>
                  <a:prstClr val="black"/>
                </a:solidFill>
                <a:latin typeface="Calibri"/>
              </a:rPr>
              <a:t>***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EACF6B94-C410-4416-A1C9-0E501402FE51}"/>
              </a:ext>
            </a:extLst>
          </p:cNvPr>
          <p:cNvSpPr txBox="1"/>
          <p:nvPr/>
        </p:nvSpPr>
        <p:spPr>
          <a:xfrm>
            <a:off x="6929120" y="2183177"/>
            <a:ext cx="518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sz="1400" b="1" dirty="0">
                <a:solidFill>
                  <a:prstClr val="black"/>
                </a:solidFill>
                <a:latin typeface="Calibri"/>
              </a:rPr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xmlns="" val="1951369745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5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imi</dc:creator>
  <cp:lastModifiedBy>Jasmine H.</cp:lastModifiedBy>
  <cp:revision>2</cp:revision>
  <dcterms:created xsi:type="dcterms:W3CDTF">2020-03-25T11:50:30Z</dcterms:created>
  <dcterms:modified xsi:type="dcterms:W3CDTF">2020-04-01T05:38:37Z</dcterms:modified>
</cp:coreProperties>
</file>